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44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08"/>
    <p:restoredTop sz="95574"/>
  </p:normalViewPr>
  <p:slideViewPr>
    <p:cSldViewPr snapToGrid="0">
      <p:cViewPr varScale="1">
        <p:scale>
          <a:sx n="105" d="100"/>
          <a:sy n="105" d="100"/>
        </p:scale>
        <p:origin x="30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88D17D-A095-E94C-A4A8-692FCC92AFB7}" type="datetimeFigureOut">
              <a:rPr lang="en-US" smtClean="0"/>
              <a:t>8/17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3F19136-5A75-1942-B03A-9A822223B5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51070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7903276-9CCB-4A88-B1B5-3167D8F58CC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52656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BD1033-1F96-DB2E-1798-BF49B3A01AB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2CF0225-7DFB-4767-6010-2D40042EA6D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88A2D3-FD93-36F3-C688-93C1DC4EF9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AD920-11CF-D54F-B870-A87CA8D2087E}" type="datetimeFigureOut">
              <a:rPr lang="en-US" smtClean="0"/>
              <a:t>8/1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419320-376E-6359-E886-95638AEA75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1AFFE8-E048-5FA1-FC64-FEC4B19691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18989-6895-7F4F-8BA4-285C23DC1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082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CD0F45-F770-2592-6478-111987E3A8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D936595-15B1-CB5A-D887-BB9C629DD6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9BBFDC-1223-518B-BBA5-27D07CFD45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AD920-11CF-D54F-B870-A87CA8D2087E}" type="datetimeFigureOut">
              <a:rPr lang="en-US" smtClean="0"/>
              <a:t>8/1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F5F8C0-170F-91E8-45BE-CC5950C7B7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DC7596-9F12-EC70-74B2-41260C720B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18989-6895-7F4F-8BA4-285C23DC1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34064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94904DE-9BD5-AACD-D8CA-C5420A9ECCC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CD1C56B-6D16-C3DF-7264-0C2FA69954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FA3627-D78B-1920-9AA1-C50FD45AD8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AD920-11CF-D54F-B870-A87CA8D2087E}" type="datetimeFigureOut">
              <a:rPr lang="en-US" smtClean="0"/>
              <a:t>8/1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40F2F4-1CA3-8529-ECEB-F980FEB150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FD6569-9511-7E34-2A31-C347E75CD5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18989-6895-7F4F-8BA4-285C23DC1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89328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4CBB79-E51F-E58A-DF06-C717F73D54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8A9598-2AD7-264B-E933-4C3FB64EE44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60AA38-5934-4564-F936-E27ED727AA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AD920-11CF-D54F-B870-A87CA8D2087E}" type="datetimeFigureOut">
              <a:rPr lang="en-US" smtClean="0"/>
              <a:t>8/1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C99F37-58A2-8DBA-0602-9D6189EB69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6B04CC-E954-8D59-2ACF-D1086B33FA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18989-6895-7F4F-8BA4-285C23DC1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99254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C041B2-AE98-89D5-F43B-4816A0243A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0A7B4C-D0D8-6012-365C-29CE75528D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9D3F71-AF63-0334-BA69-FB6B0800A2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AD920-11CF-D54F-B870-A87CA8D2087E}" type="datetimeFigureOut">
              <a:rPr lang="en-US" smtClean="0"/>
              <a:t>8/1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EC0478-9920-4C15-8F0F-379710DE48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A7AF0F-CC27-E0AB-D920-D4EA9BD76C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18989-6895-7F4F-8BA4-285C23DC1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01360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70389B-F339-9BC1-3880-48CF142FD5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18C72D-7F15-6246-B128-AD566583D5E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54C8A65-5BEF-F8AA-DFF9-9AD0EA18E8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22AB4C-D0B3-6AE8-6A2D-96458A9BFA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AD920-11CF-D54F-B870-A87CA8D2087E}" type="datetimeFigureOut">
              <a:rPr lang="en-US" smtClean="0"/>
              <a:t>8/1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3771EE-7569-D17B-0EFF-2F7A0A7ED1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B9A21B4-A849-2A3C-B638-62C06076D6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18989-6895-7F4F-8BA4-285C23DC1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40037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A3F25E-CB01-DD15-787C-1B9A7241A8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5B3571C-1560-D2E2-8C6D-6B34AE6405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60B2EFF-6801-D5B1-C264-4526068E9F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27CADD6-B975-0273-F413-21E3BDC85D2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A128780-4B15-6B77-C856-AAE136F1DD5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B3317A0-1688-B95D-0071-05734B8BD5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AD920-11CF-D54F-B870-A87CA8D2087E}" type="datetimeFigureOut">
              <a:rPr lang="en-US" smtClean="0"/>
              <a:t>8/17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60027CD-2E6D-7E0F-C782-BB7906A06D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F43200D-DFE0-785A-2852-9DFD63F332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18989-6895-7F4F-8BA4-285C23DC1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8330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63FF40-2DF2-A2CA-F1FB-08A75E8F2B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C259DF4-A8BF-0438-9491-300D589F87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AD920-11CF-D54F-B870-A87CA8D2087E}" type="datetimeFigureOut">
              <a:rPr lang="en-US" smtClean="0"/>
              <a:t>8/17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11FC46B-0DDE-B147-4972-A0490F8CC3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C9BAAFE-79F5-0E11-1509-6E0DDA4C66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18989-6895-7F4F-8BA4-285C23DC1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05847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EFFA55D-274E-353B-492F-74E77C77BD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AD920-11CF-D54F-B870-A87CA8D2087E}" type="datetimeFigureOut">
              <a:rPr lang="en-US" smtClean="0"/>
              <a:t>8/17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E9BB586-55C7-8EAA-3BCF-B8615CB4CC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71BE4FD-1FDE-C23C-92C3-D89CDCAFF6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18989-6895-7F4F-8BA4-285C23DC1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86685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9E9F3B-03F1-1AD2-5D68-C1B6008800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0726C18-B982-FBF7-011C-107493A1682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A1D3DD9-9230-1BAE-5E3F-A58759B72D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5EF607-7D67-A1BD-A6CD-1D274301B1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AD920-11CF-D54F-B870-A87CA8D2087E}" type="datetimeFigureOut">
              <a:rPr lang="en-US" smtClean="0"/>
              <a:t>8/1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7F7FA1-16D5-69B2-CF32-8E7D67A4F0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861977-84D0-66A9-6997-67C65C8FE6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18989-6895-7F4F-8BA4-285C23DC1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06846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0ED0E6-4FAB-BA1E-0FED-64DB53EB5C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00E39E4-DE15-BD4B-59AC-FF64A6B4A97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A909EE8-6B83-BF43-38D0-485D2DB150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C2BF05-6548-A78C-119C-15D46223A8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AD920-11CF-D54F-B870-A87CA8D2087E}" type="datetimeFigureOut">
              <a:rPr lang="en-US" smtClean="0"/>
              <a:t>8/1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D96E623-8DA0-01AE-5CE6-C088041C15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6C4D1F5-94D2-0445-6BC6-D8292FCD9B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18989-6895-7F4F-8BA4-285C23DC1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92488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77C4AF5-B5F7-D5D8-7BC8-6D3A9F3F7D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B4A3992-CC4B-718D-A03E-B197B0F6C5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A006E2-6F52-CEA5-1E9D-7414ECCB443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6AD920-11CF-D54F-B870-A87CA8D2087E}" type="datetimeFigureOut">
              <a:rPr lang="en-US" smtClean="0"/>
              <a:t>8/1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EE0DB1-AC49-52B8-C764-6933339E9B0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C6117C-2377-D23C-C68C-8DB764574E4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D18989-6895-7F4F-8BA4-285C23DC1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78884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662F8E-A29D-764F-9753-8321F513BB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l </a:t>
            </a:r>
            <a:r>
              <a:rPr lang="en-US"/>
              <a:t>Figure 1</a:t>
            </a:r>
            <a:endParaRPr lang="en-US" dirty="0"/>
          </a:p>
        </p:txBody>
      </p:sp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87B11EEF-E0BE-274A-8B76-D6BB718FF7E3}"/>
              </a:ext>
            </a:extLst>
          </p:cNvPr>
          <p:cNvGraphicFramePr>
            <a:graphicFrameLocks noGrp="1"/>
          </p:cNvGraphicFramePr>
          <p:nvPr/>
        </p:nvGraphicFramePr>
        <p:xfrm>
          <a:off x="336224" y="2272889"/>
          <a:ext cx="6752492" cy="2312221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2082909">
                  <a:extLst>
                    <a:ext uri="{9D8B030D-6E8A-4147-A177-3AD203B41FA5}">
                      <a16:colId xmlns:a16="http://schemas.microsoft.com/office/drawing/2014/main" val="2272360477"/>
                    </a:ext>
                  </a:extLst>
                </a:gridCol>
                <a:gridCol w="1366827">
                  <a:extLst>
                    <a:ext uri="{9D8B030D-6E8A-4147-A177-3AD203B41FA5}">
                      <a16:colId xmlns:a16="http://schemas.microsoft.com/office/drawing/2014/main" val="546747101"/>
                    </a:ext>
                  </a:extLst>
                </a:gridCol>
                <a:gridCol w="2250857">
                  <a:extLst>
                    <a:ext uri="{9D8B030D-6E8A-4147-A177-3AD203B41FA5}">
                      <a16:colId xmlns:a16="http://schemas.microsoft.com/office/drawing/2014/main" val="3417154958"/>
                    </a:ext>
                  </a:extLst>
                </a:gridCol>
                <a:gridCol w="1051899">
                  <a:extLst>
                    <a:ext uri="{9D8B030D-6E8A-4147-A177-3AD203B41FA5}">
                      <a16:colId xmlns:a16="http://schemas.microsoft.com/office/drawing/2014/main" val="1416903669"/>
                    </a:ext>
                  </a:extLst>
                </a:gridCol>
              </a:tblGrid>
              <a:tr h="86683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Markers of inflammation (N=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Correlation coefficien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Confidence interva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p valu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69726936"/>
                  </a:ext>
                </a:extLst>
              </a:tr>
              <a:tr h="419299">
                <a:tc>
                  <a:txBody>
                    <a:bodyPr/>
                    <a:lstStyle/>
                    <a:p>
                      <a:r>
                        <a:rPr lang="en-US" dirty="0"/>
                        <a:t>CRP (95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-0.6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-1.34, -0.000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0.0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37300163"/>
                  </a:ext>
                </a:extLst>
              </a:tr>
              <a:tr h="419299">
                <a:tc>
                  <a:txBody>
                    <a:bodyPr/>
                    <a:lstStyle/>
                    <a:p>
                      <a:r>
                        <a:rPr lang="en-US" dirty="0"/>
                        <a:t>ESR (93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-0.0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-0.097, 0.04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0.4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2326092"/>
                  </a:ext>
                </a:extLst>
              </a:tr>
              <a:tr h="606786">
                <a:tc>
                  <a:txBody>
                    <a:bodyPr/>
                    <a:lstStyle/>
                    <a:p>
                      <a:r>
                        <a:rPr lang="en-US" dirty="0"/>
                        <a:t>Albumin (114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.1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-0.84, 5.2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0.1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67556739"/>
                  </a:ext>
                </a:extLst>
              </a:tr>
            </a:tbl>
          </a:graphicData>
        </a:graphic>
      </p:graphicFrame>
      <p:grpSp>
        <p:nvGrpSpPr>
          <p:cNvPr id="7" name="Group 6">
            <a:extLst>
              <a:ext uri="{FF2B5EF4-FFF2-40B4-BE49-F238E27FC236}">
                <a16:creationId xmlns:a16="http://schemas.microsoft.com/office/drawing/2014/main" id="{2FCDD981-970F-1E41-A5F0-34AB415B4BF4}"/>
              </a:ext>
            </a:extLst>
          </p:cNvPr>
          <p:cNvGrpSpPr/>
          <p:nvPr/>
        </p:nvGrpSpPr>
        <p:grpSpPr>
          <a:xfrm>
            <a:off x="7859379" y="1690688"/>
            <a:ext cx="3996397" cy="4288081"/>
            <a:chOff x="7241116" y="1690688"/>
            <a:chExt cx="4112684" cy="4433154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D7F86114-CCAE-A04C-9273-557A95C0C53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241116" y="1690688"/>
              <a:ext cx="3960284" cy="4433154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7DC868C2-BB99-8A4B-88EE-B04B14353B89}"/>
                </a:ext>
              </a:extLst>
            </p:cNvPr>
            <p:cNvSpPr txBox="1"/>
            <p:nvPr/>
          </p:nvSpPr>
          <p:spPr>
            <a:xfrm>
              <a:off x="8271803" y="5697414"/>
              <a:ext cx="3081997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Time of Year Obtaine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2342458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3</Words>
  <Application>Microsoft Macintosh PowerPoint</Application>
  <PresentationFormat>Widescreen</PresentationFormat>
  <Paragraphs>1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Supplemental Figure 1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 1</dc:title>
  <dc:creator>Lai Xue</dc:creator>
  <cp:lastModifiedBy>Lai Xue</cp:lastModifiedBy>
  <cp:revision>1</cp:revision>
  <dcterms:created xsi:type="dcterms:W3CDTF">2022-08-17T15:00:23Z</dcterms:created>
  <dcterms:modified xsi:type="dcterms:W3CDTF">2022-08-17T15:00:33Z</dcterms:modified>
</cp:coreProperties>
</file>